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881BA0-ECCA-4028-864A-B6E30D4D477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68C95D-3436-4819-B69B-EABF90E7469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AED2EC-8D67-457E-B2F3-DB2AE51D5D7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EE2D00-2B47-49A1-90F0-69FFB8FC686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72F6D4-09F7-4FD3-BFF0-CF6EE969B92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F1E21A-C99A-468E-B78B-15BD8EC1A9F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B3A3D6-8D4A-4C88-AEEA-5FC6920E37B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7789CD-F0C5-45E4-B21A-1DFFD0B3F34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2B393A-2E12-4F04-98E1-33DD219FB23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1FA1DF-4649-4485-A49C-49358201C5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DA6C8E-795E-47A5-A592-02CDD4393D9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542493-3FA4-4E6A-9C80-EB1B3D41E4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549DE6F-A8B8-4912-B1F3-AFFBEB78F4D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png"/><Relationship Id="rId3" Type="http://schemas.openxmlformats.org/officeDocument/2006/relationships/package" Target="../embeddings/oleObject2.xlsx"/><Relationship Id="rId4" Type="http://schemas.openxmlformats.org/officeDocument/2006/relationships/image" Target="../media/image2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66760" y="1432080"/>
            <a:ext cx="3139920" cy="3439080"/>
            <a:chOff x="266760" y="1432080"/>
            <a:chExt cx="3139920" cy="3439080"/>
          </a:xfrm>
        </p:grpSpPr>
        <p:graphicFrame>
          <p:nvGraphicFramePr>
            <p:cNvPr id="42" name=""/>
            <p:cNvGraphicFramePr/>
            <p:nvPr/>
          </p:nvGraphicFramePr>
          <p:xfrm>
            <a:off x="266760" y="1432080"/>
            <a:ext cx="3139920" cy="3003480"/>
          </p:xfrm>
          <a:graphic>
            <a:graphicData uri="http://schemas.openxmlformats.org/presentationml/2006/ole">
              <p:oleObj progId="Excel.Sheet.12" r:id="rId1" spid="">
                <p:embed/>
                <p:pic>
                  <p:nvPicPr>
                    <p:cNvPr id="43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266760" y="1432080"/>
                      <a:ext cx="3139920" cy="30034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44" name=""/>
            <p:cNvSpPr/>
            <p:nvPr/>
          </p:nvSpPr>
          <p:spPr>
            <a:xfrm>
              <a:off x="1312920" y="4214880"/>
              <a:ext cx="531720" cy="24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wt/w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2457360" y="4206960"/>
              <a:ext cx="755640" cy="24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mut/mu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1388880" y="4564080"/>
              <a:ext cx="1503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400" spc="-1" strike="noStrike">
                  <a:solidFill>
                    <a:srgbClr val="000000"/>
                  </a:solidFill>
                  <a:latin typeface="Arial"/>
                </a:rPr>
                <a:t>Genotype of rat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7" name=""/>
          <p:cNvGrpSpPr/>
          <p:nvPr/>
        </p:nvGrpSpPr>
        <p:grpSpPr>
          <a:xfrm>
            <a:off x="3979800" y="1257480"/>
            <a:ext cx="3617640" cy="3632760"/>
            <a:chOff x="3979800" y="1257480"/>
            <a:chExt cx="3617640" cy="3632760"/>
          </a:xfrm>
        </p:grpSpPr>
        <p:graphicFrame>
          <p:nvGraphicFramePr>
            <p:cNvPr id="48" name=""/>
            <p:cNvGraphicFramePr/>
            <p:nvPr/>
          </p:nvGraphicFramePr>
          <p:xfrm>
            <a:off x="3979800" y="1257480"/>
            <a:ext cx="3617640" cy="3016080"/>
          </p:xfrm>
          <a:graphic>
            <a:graphicData uri="http://schemas.openxmlformats.org/presentationml/2006/ole">
              <p:oleObj progId="Excel.Sheet.12" r:id="rId3" spid="">
                <p:embed/>
                <p:pic>
                  <p:nvPicPr>
                    <p:cNvPr id="49" name="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3979800" y="1257480"/>
                      <a:ext cx="3617640" cy="30160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50" name=""/>
            <p:cNvSpPr/>
            <p:nvPr/>
          </p:nvSpPr>
          <p:spPr>
            <a:xfrm>
              <a:off x="5446080" y="4583160"/>
              <a:ext cx="12535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400" spc="-1" strike="noStrike">
                  <a:solidFill>
                    <a:srgbClr val="000000"/>
                  </a:solidFill>
                  <a:latin typeface="Arial"/>
                </a:rPr>
                <a:t>Primary cells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5033880" y="4230720"/>
              <a:ext cx="826920" cy="24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REF7 (wt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6225840" y="4222800"/>
              <a:ext cx="1013040" cy="24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REF 10 (mut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3" name=""/>
          <p:cNvGrpSpPr/>
          <p:nvPr/>
        </p:nvGrpSpPr>
        <p:grpSpPr>
          <a:xfrm>
            <a:off x="7534440" y="2716200"/>
            <a:ext cx="1008000" cy="424080"/>
            <a:chOff x="7534440" y="2716200"/>
            <a:chExt cx="1008000" cy="424080"/>
          </a:xfrm>
        </p:grpSpPr>
        <p:sp>
          <p:nvSpPr>
            <p:cNvPr id="54" name=""/>
            <p:cNvSpPr/>
            <p:nvPr/>
          </p:nvSpPr>
          <p:spPr>
            <a:xfrm>
              <a:off x="7534440" y="2781000"/>
              <a:ext cx="95040" cy="105120"/>
            </a:xfrm>
            <a:prstGeom prst="rect">
              <a:avLst/>
            </a:prstGeom>
            <a:solidFill>
              <a:srgbClr val="339966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7534440" y="2968560"/>
              <a:ext cx="95040" cy="104760"/>
            </a:xfrm>
            <a:prstGeom prst="rect">
              <a:avLst/>
            </a:prstGeom>
            <a:solidFill>
              <a:srgbClr val="ffff66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7578360" y="2716200"/>
              <a:ext cx="964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= miRNA-22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7575120" y="2894040"/>
              <a:ext cx="964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= miRNA-22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8" name=""/>
          <p:cNvSpPr/>
          <p:nvPr/>
        </p:nvSpPr>
        <p:spPr>
          <a:xfrm>
            <a:off x="467640" y="212760"/>
            <a:ext cx="1626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dditional File 7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1273320" y="1274760"/>
            <a:ext cx="1625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Adrenal tissu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5528160" y="1274760"/>
            <a:ext cx="1104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Cell li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18T11:11:51Z</dcterms:created>
  <dc:creator>natalia.pellegata</dc:creator>
  <dc:description/>
  <dc:language>en-US</dc:language>
  <cp:lastModifiedBy>natalia.pellegata</cp:lastModifiedBy>
  <dcterms:modified xsi:type="dcterms:W3CDTF">2010-05-18T11:12:07Z</dcterms:modified>
  <cp:revision>1</cp:revision>
  <dc:subject/>
  <dc:title>Slide 1</dc:title>
</cp:coreProperties>
</file>